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E1328-8A6F-4FFB-8BE8-BB73E52DCD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8D31F-5BF4-4B26-BEA4-E19E97D9E9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572AF1-7F27-4D56-8A6A-CFE693305B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B2B85C-BD3C-4BD9-BE68-F5233F522B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A904C-A253-4678-B29D-266423A669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302B14-107F-4635-A162-DA830949C8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CE113-C279-4E86-B2F0-4514F05383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45D8C-3BEE-4D6C-8401-CB5566C647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074B1-D5F5-4C21-BC93-3EB4D76544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3D255-AA6E-4204-B7FB-CEF2D61F32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9DE27-FA8E-48EC-BD26-C485F22968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04EDA8-F994-4F73-8B1B-C630E25702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94CDFA-8B1D-43D8-B02A-9D5AE80573E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33520" y="2515320"/>
            <a:ext cx="5638680" cy="435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Rat genome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CAGTTCGGGAT-G-GCCGGCGAGGCTCGCTGTCCCGAGACCCACAGCTGT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|| |||||||| | ||  |||  || ||  ||   | | ||  | ||||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Human genome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CATTTCGGGATGGAGCAAGCGCAGCGCGAAGTTGGGCGCCCGCCGGCTG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Rat genome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CA-CAGGCTGCGGCCAGAGCCCCTCCCCGAGGACGCCTCCGCCT-CTGGT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|| |||    | ||| | | | |||   ||   |  ||| |||| | |||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Human genome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CAGCAGAACCCCGCCCGCGGCGCTCTAGGACTGCATCTCGGCCTCCGGGT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Rat genome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GGAGAGCTGGCGACCCTGCTGTGCCTTGGGAGCCGAGCTTGCTCGTTTCC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| || |||||   ||||||| | |   || |||  |  | |  | |||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Human genome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CGCGACCTGGCTGTCCTGCTGGGTC-CCGG-GCCTCGGGT-C-GGCTTCA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Rat genome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CGCGATTAGGGGGTACA--AACTGCA--CAT-CCCCCGCCCGGCTGGGAT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||| ||| ||||| ||    |||||  | | |    |||||| ||||||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Human genome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GGCGGTTAAGGGGTGCATGCTCTGCACCCCTGCGGGAGCCCGG-TGGGAT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Rat genome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TGGCCGGTGGGCTGGGACAACATGAGCCCTGCCAAATGCAAGGTCTGTTT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||||| | ||| | || ||||||||| |||||||| |||||| |||||||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Human genome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TGGCCTGCGGGGT-GGTCAA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MS Mincho"/>
              </a:rPr>
              <a:t>ATGAGTCCTGCCAAGTGCAAGATCTGT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Rat genome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CCCTGAGCTCACAGGAAAgtaag......ctcag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GCCCAGCATGTCTGG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|||||| | |  || |||&gt;&gt;&gt;&gt;&gt; 7449 &gt;&gt;&gt;&gt;&gt;||| |||||||| |||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241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Human genome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	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MS Mincho"/>
              </a:rPr>
              <a:t>CCCTGATCGCGAAGT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MS Mincho"/>
              </a:rPr>
              <a:t>................</a:t>
            </a:r>
            <a:r>
              <a:rPr b="0" i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MS Mincho"/>
              </a:rPr>
              <a:t>GCCGAGCATGTCGGG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60" y="0"/>
            <a:ext cx="269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S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7T16:39:31Z</dcterms:created>
  <dc:creator>John Castle</dc:creator>
  <dc:description/>
  <dc:language>en-US</dc:language>
  <cp:lastModifiedBy>Merck</cp:lastModifiedBy>
  <dcterms:modified xsi:type="dcterms:W3CDTF">2008-07-10T05:04:28Z</dcterms:modified>
  <cp:revision>11</cp:revision>
  <dc:subject/>
  <dc:title>Slide 1</dc:title>
</cp:coreProperties>
</file>